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2991092829384618E-2"/>
          <c:y val="1.3744840720740344E-2"/>
          <c:w val="0.88875432019405864"/>
          <c:h val="0.84214466218357986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graph!$D$40</c:f>
              <c:strCache>
                <c:ptCount val="1"/>
                <c:pt idx="0">
                  <c:v>400 µg/m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]Mag  monoacetile'!$F$41:$F$55</c:f>
                <c:numCache>
                  <c:formatCode>General</c:formatCode>
                  <c:ptCount val="15"/>
                  <c:pt idx="0">
                    <c:v>1.8445518833054992</c:v>
                  </c:pt>
                  <c:pt idx="1">
                    <c:v>5.2486388108147786</c:v>
                  </c:pt>
                  <c:pt idx="2">
                    <c:v>1.8282758524338136</c:v>
                  </c:pt>
                  <c:pt idx="3">
                    <c:v>7.8676756461587543</c:v>
                  </c:pt>
                  <c:pt idx="4">
                    <c:v>5.9725889916168189</c:v>
                  </c:pt>
                  <c:pt idx="5">
                    <c:v>0</c:v>
                  </c:pt>
                  <c:pt idx="6">
                    <c:v>1.7299924060513541</c:v>
                  </c:pt>
                  <c:pt idx="7">
                    <c:v>1.9908629972056033</c:v>
                  </c:pt>
                  <c:pt idx="8">
                    <c:v>3.5509079391571547</c:v>
                  </c:pt>
                  <c:pt idx="9">
                    <c:v>13.323467750529826</c:v>
                  </c:pt>
                  <c:pt idx="10">
                    <c:v>1.1503183731482085</c:v>
                  </c:pt>
                  <c:pt idx="11">
                    <c:v>3.5665644912933883</c:v>
                  </c:pt>
                  <c:pt idx="12">
                    <c:v>1.5700784624746069</c:v>
                  </c:pt>
                  <c:pt idx="13">
                    <c:v>1.9245008972987538</c:v>
                  </c:pt>
                  <c:pt idx="14">
                    <c:v>3.0898780743013057</c:v>
                  </c:pt>
                </c:numCache>
              </c:numRef>
            </c:plus>
            <c:minus>
              <c:numRef>
                <c:f>'[1]Mag  monoacetile'!$F$41:$F$55</c:f>
                <c:numCache>
                  <c:formatCode>General</c:formatCode>
                  <c:ptCount val="15"/>
                  <c:pt idx="0">
                    <c:v>1.8445518833054992</c:v>
                  </c:pt>
                  <c:pt idx="1">
                    <c:v>5.2486388108147786</c:v>
                  </c:pt>
                  <c:pt idx="2">
                    <c:v>1.8282758524338136</c:v>
                  </c:pt>
                  <c:pt idx="3">
                    <c:v>7.8676756461587543</c:v>
                  </c:pt>
                  <c:pt idx="4">
                    <c:v>5.9725889916168189</c:v>
                  </c:pt>
                  <c:pt idx="5">
                    <c:v>0</c:v>
                  </c:pt>
                  <c:pt idx="6">
                    <c:v>1.7299924060513541</c:v>
                  </c:pt>
                  <c:pt idx="7">
                    <c:v>1.9908629972056033</c:v>
                  </c:pt>
                  <c:pt idx="8">
                    <c:v>3.5509079391571547</c:v>
                  </c:pt>
                  <c:pt idx="9">
                    <c:v>13.323467750529826</c:v>
                  </c:pt>
                  <c:pt idx="10">
                    <c:v>1.1503183731482085</c:v>
                  </c:pt>
                  <c:pt idx="11">
                    <c:v>3.5665644912933883</c:v>
                  </c:pt>
                  <c:pt idx="12">
                    <c:v>1.5700784624746069</c:v>
                  </c:pt>
                  <c:pt idx="13">
                    <c:v>1.9245008972987538</c:v>
                  </c:pt>
                  <c:pt idx="14">
                    <c:v>3.0898780743013057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41:$D$55</c:f>
              <c:numCache>
                <c:formatCode>0.0</c:formatCode>
                <c:ptCount val="15"/>
                <c:pt idx="0">
                  <c:v>24.712643678160919</c:v>
                </c:pt>
                <c:pt idx="1">
                  <c:v>0</c:v>
                </c:pt>
                <c:pt idx="2">
                  <c:v>16.444444444444446</c:v>
                </c:pt>
                <c:pt idx="3">
                  <c:v>2.4691358024691357</c:v>
                </c:pt>
                <c:pt idx="4">
                  <c:v>0</c:v>
                </c:pt>
                <c:pt idx="5">
                  <c:v>0</c:v>
                </c:pt>
                <c:pt idx="6">
                  <c:v>29.064039408866993</c:v>
                </c:pt>
                <c:pt idx="7">
                  <c:v>40.229885057471272</c:v>
                </c:pt>
                <c:pt idx="8">
                  <c:v>23.920377867746293</c:v>
                </c:pt>
                <c:pt idx="9">
                  <c:v>0</c:v>
                </c:pt>
                <c:pt idx="10">
                  <c:v>6.1669829222011385</c:v>
                </c:pt>
                <c:pt idx="11">
                  <c:v>24.061624649859947</c:v>
                </c:pt>
                <c:pt idx="12">
                  <c:v>18.003565062388592</c:v>
                </c:pt>
                <c:pt idx="13">
                  <c:v>25.555555555555557</c:v>
                </c:pt>
                <c:pt idx="14">
                  <c:v>12.8427419354838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BC7-4104-9E90-F5BD90071796}"/>
            </c:ext>
          </c:extLst>
        </c:ser>
        <c:ser>
          <c:idx val="6"/>
          <c:order val="1"/>
          <c:tx>
            <c:strRef>
              <c:f>graph!$F$40</c:f>
              <c:strCache>
                <c:ptCount val="1"/>
                <c:pt idx="0">
                  <c:v>200 µg/ml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1]Mag  monoacetile'!$J$41:$J$55</c:f>
                <c:numCache>
                  <c:formatCode>General</c:formatCode>
                  <c:ptCount val="15"/>
                  <c:pt idx="0">
                    <c:v>2.9151922459082096</c:v>
                  </c:pt>
                  <c:pt idx="1">
                    <c:v>3.5434427583863455</c:v>
                  </c:pt>
                  <c:pt idx="2">
                    <c:v>2.1278575558006176</c:v>
                  </c:pt>
                  <c:pt idx="3">
                    <c:v>3.4943288040166922</c:v>
                  </c:pt>
                  <c:pt idx="4">
                    <c:v>10.731296538996578</c:v>
                  </c:pt>
                  <c:pt idx="5">
                    <c:v>4.8877907815604065</c:v>
                  </c:pt>
                  <c:pt idx="6">
                    <c:v>0.92432924870260202</c:v>
                  </c:pt>
                  <c:pt idx="7">
                    <c:v>1.9908629972056073</c:v>
                  </c:pt>
                  <c:pt idx="8">
                    <c:v>0.49538028452885857</c:v>
                  </c:pt>
                  <c:pt idx="9">
                    <c:v>2.2205779584216336</c:v>
                  </c:pt>
                  <c:pt idx="10">
                    <c:v>3.6977562181983057</c:v>
                  </c:pt>
                  <c:pt idx="11">
                    <c:v>0.67923561081132611</c:v>
                  </c:pt>
                  <c:pt idx="12">
                    <c:v>1.5229953200209505</c:v>
                  </c:pt>
                  <c:pt idx="13">
                    <c:v>0</c:v>
                  </c:pt>
                  <c:pt idx="14">
                    <c:v>2.1170243765827528</c:v>
                  </c:pt>
                </c:numCache>
              </c:numRef>
            </c:plus>
            <c:minus>
              <c:numRef>
                <c:f>'[1]Mag  monoacetile'!$J$41:$J$55</c:f>
                <c:numCache>
                  <c:formatCode>General</c:formatCode>
                  <c:ptCount val="15"/>
                  <c:pt idx="0">
                    <c:v>2.9151922459082096</c:v>
                  </c:pt>
                  <c:pt idx="1">
                    <c:v>3.5434427583863455</c:v>
                  </c:pt>
                  <c:pt idx="2">
                    <c:v>2.1278575558006176</c:v>
                  </c:pt>
                  <c:pt idx="3">
                    <c:v>3.4943288040166922</c:v>
                  </c:pt>
                  <c:pt idx="4">
                    <c:v>10.731296538996578</c:v>
                  </c:pt>
                  <c:pt idx="5">
                    <c:v>4.8877907815604065</c:v>
                  </c:pt>
                  <c:pt idx="6">
                    <c:v>0.92432924870260202</c:v>
                  </c:pt>
                  <c:pt idx="7">
                    <c:v>1.9908629972056073</c:v>
                  </c:pt>
                  <c:pt idx="8">
                    <c:v>0.49538028452885857</c:v>
                  </c:pt>
                  <c:pt idx="9">
                    <c:v>2.2205779584216336</c:v>
                  </c:pt>
                  <c:pt idx="10">
                    <c:v>3.6977562181983057</c:v>
                  </c:pt>
                  <c:pt idx="11">
                    <c:v>0.67923561081132611</c:v>
                  </c:pt>
                  <c:pt idx="12">
                    <c:v>1.5229953200209505</c:v>
                  </c:pt>
                  <c:pt idx="13">
                    <c:v>0</c:v>
                  </c:pt>
                  <c:pt idx="14">
                    <c:v>2.1170243765827528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41:$F$55</c:f>
              <c:numCache>
                <c:formatCode>0.0</c:formatCode>
                <c:ptCount val="15"/>
                <c:pt idx="0">
                  <c:v>27.052545155993432</c:v>
                </c:pt>
                <c:pt idx="1">
                  <c:v>3.0303030303030298</c:v>
                </c:pt>
                <c:pt idx="2">
                  <c:v>21.888888888888889</c:v>
                </c:pt>
                <c:pt idx="3">
                  <c:v>8.9382716049382704</c:v>
                </c:pt>
                <c:pt idx="4">
                  <c:v>3.4482758620689657</c:v>
                </c:pt>
                <c:pt idx="5">
                  <c:v>0</c:v>
                </c:pt>
                <c:pt idx="6">
                  <c:v>43.021346469622337</c:v>
                </c:pt>
                <c:pt idx="7">
                  <c:v>45.977011494252871</c:v>
                </c:pt>
                <c:pt idx="8">
                  <c:v>30.13945119208277</c:v>
                </c:pt>
                <c:pt idx="9">
                  <c:v>7.6923076923076925</c:v>
                </c:pt>
                <c:pt idx="10">
                  <c:v>21.916508538899432</c:v>
                </c:pt>
                <c:pt idx="11">
                  <c:v>26.946778711484598</c:v>
                </c:pt>
                <c:pt idx="12">
                  <c:v>25.995246583481883</c:v>
                </c:pt>
                <c:pt idx="13">
                  <c:v>32.222222222222221</c:v>
                </c:pt>
                <c:pt idx="14">
                  <c:v>21.4516129032258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BC7-4104-9E90-F5BD90071796}"/>
            </c:ext>
          </c:extLst>
        </c:ser>
        <c:ser>
          <c:idx val="10"/>
          <c:order val="2"/>
          <c:tx>
            <c:strRef>
              <c:f>graph!$H$40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]Mag  monoacetile'!$N$41:$N$55</c:f>
                <c:numCache>
                  <c:formatCode>General</c:formatCode>
                  <c:ptCount val="15"/>
                  <c:pt idx="0">
                    <c:v>3.5777928685551581</c:v>
                  </c:pt>
                  <c:pt idx="1">
                    <c:v>2.7492869961410817</c:v>
                  </c:pt>
                  <c:pt idx="2">
                    <c:v>2.2047927592204957</c:v>
                  </c:pt>
                  <c:pt idx="3">
                    <c:v>6.2439362445692996</c:v>
                  </c:pt>
                  <c:pt idx="4">
                    <c:v>21.563449777611364</c:v>
                  </c:pt>
                  <c:pt idx="5">
                    <c:v>2.0262666945253538</c:v>
                  </c:pt>
                  <c:pt idx="6">
                    <c:v>1.9197607473054017</c:v>
                  </c:pt>
                  <c:pt idx="7">
                    <c:v>0</c:v>
                  </c:pt>
                  <c:pt idx="8">
                    <c:v>2.3916864206090516</c:v>
                  </c:pt>
                  <c:pt idx="9">
                    <c:v>0</c:v>
                  </c:pt>
                  <c:pt idx="10">
                    <c:v>3.8589655307592889</c:v>
                  </c:pt>
                  <c:pt idx="11">
                    <c:v>4.1358996355968412</c:v>
                  </c:pt>
                  <c:pt idx="12">
                    <c:v>1.5437172972984718</c:v>
                  </c:pt>
                  <c:pt idx="13">
                    <c:v>3.3333333333333357</c:v>
                  </c:pt>
                  <c:pt idx="14">
                    <c:v>3.145505908883889</c:v>
                  </c:pt>
                </c:numCache>
              </c:numRef>
            </c:plus>
            <c:minus>
              <c:numRef>
                <c:f>'[1]Mag  monoacetile'!$N$41:$N$55</c:f>
                <c:numCache>
                  <c:formatCode>General</c:formatCode>
                  <c:ptCount val="15"/>
                  <c:pt idx="0">
                    <c:v>3.5777928685551581</c:v>
                  </c:pt>
                  <c:pt idx="1">
                    <c:v>2.7492869961410817</c:v>
                  </c:pt>
                  <c:pt idx="2">
                    <c:v>2.2047927592204957</c:v>
                  </c:pt>
                  <c:pt idx="3">
                    <c:v>6.2439362445692996</c:v>
                  </c:pt>
                  <c:pt idx="4">
                    <c:v>21.563449777611364</c:v>
                  </c:pt>
                  <c:pt idx="5">
                    <c:v>2.0262666945253538</c:v>
                  </c:pt>
                  <c:pt idx="6">
                    <c:v>1.9197607473054017</c:v>
                  </c:pt>
                  <c:pt idx="7">
                    <c:v>0</c:v>
                  </c:pt>
                  <c:pt idx="8">
                    <c:v>2.3916864206090516</c:v>
                  </c:pt>
                  <c:pt idx="9">
                    <c:v>0</c:v>
                  </c:pt>
                  <c:pt idx="10">
                    <c:v>3.8589655307592889</c:v>
                  </c:pt>
                  <c:pt idx="11">
                    <c:v>4.1358996355968412</c:v>
                  </c:pt>
                  <c:pt idx="12">
                    <c:v>1.5437172972984718</c:v>
                  </c:pt>
                  <c:pt idx="13">
                    <c:v>3.3333333333333357</c:v>
                  </c:pt>
                  <c:pt idx="14">
                    <c:v>3.145505908883889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41:$H$55</c:f>
              <c:numCache>
                <c:formatCode>0.0</c:formatCode>
                <c:ptCount val="15"/>
                <c:pt idx="0">
                  <c:v>37.643678160919542</c:v>
                </c:pt>
                <c:pt idx="1">
                  <c:v>23.448773448773448</c:v>
                </c:pt>
                <c:pt idx="2">
                  <c:v>34.277777777777779</c:v>
                </c:pt>
                <c:pt idx="3">
                  <c:v>9.0370370370370363</c:v>
                </c:pt>
                <c:pt idx="4">
                  <c:v>14.039408866995075</c:v>
                </c:pt>
                <c:pt idx="5">
                  <c:v>16.286799620132953</c:v>
                </c:pt>
                <c:pt idx="6">
                  <c:v>48.850574712643684</c:v>
                </c:pt>
                <c:pt idx="7">
                  <c:v>52.873563218390807</c:v>
                </c:pt>
                <c:pt idx="8">
                  <c:v>38.990103463787676</c:v>
                </c:pt>
                <c:pt idx="9">
                  <c:v>44.871794871794869</c:v>
                </c:pt>
                <c:pt idx="10">
                  <c:v>34.440227703984817</c:v>
                </c:pt>
                <c:pt idx="11">
                  <c:v>36.554621848739494</c:v>
                </c:pt>
                <c:pt idx="12">
                  <c:v>36.987522281639933</c:v>
                </c:pt>
                <c:pt idx="13">
                  <c:v>41.111111111111114</c:v>
                </c:pt>
                <c:pt idx="14">
                  <c:v>29.0524193548387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BC7-4104-9E90-F5BD90071796}"/>
            </c:ext>
          </c:extLst>
        </c:ser>
        <c:ser>
          <c:idx val="3"/>
          <c:order val="3"/>
          <c:tx>
            <c:strRef>
              <c:f>graph!$J$40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F024D8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41:$K$55</c:f>
                <c:numCache>
                  <c:formatCode>General</c:formatCode>
                  <c:ptCount val="15"/>
                  <c:pt idx="0">
                    <c:v>2.9151922459082096</c:v>
                  </c:pt>
                  <c:pt idx="1">
                    <c:v>3.5434427583863455</c:v>
                  </c:pt>
                  <c:pt idx="2">
                    <c:v>2.1278575558006176</c:v>
                  </c:pt>
                  <c:pt idx="3">
                    <c:v>3.4943288040166922</c:v>
                  </c:pt>
                  <c:pt idx="4">
                    <c:v>10.731296538996578</c:v>
                  </c:pt>
                  <c:pt idx="5">
                    <c:v>4.8877907815604065</c:v>
                  </c:pt>
                  <c:pt idx="6">
                    <c:v>0.92432924870260202</c:v>
                  </c:pt>
                  <c:pt idx="7">
                    <c:v>1.9908629972056073</c:v>
                  </c:pt>
                  <c:pt idx="8">
                    <c:v>0.49538028452885857</c:v>
                  </c:pt>
                  <c:pt idx="9">
                    <c:v>2.2205779584216336</c:v>
                  </c:pt>
                  <c:pt idx="10">
                    <c:v>3.6977562181983057</c:v>
                  </c:pt>
                  <c:pt idx="11">
                    <c:v>0.67923561081132611</c:v>
                  </c:pt>
                  <c:pt idx="12">
                    <c:v>1.5229953200209505</c:v>
                  </c:pt>
                  <c:pt idx="13">
                    <c:v>0</c:v>
                  </c:pt>
                  <c:pt idx="14">
                    <c:v>2.1170243765827528</c:v>
                  </c:pt>
                </c:numCache>
              </c:numRef>
            </c:plus>
            <c:minus>
              <c:numRef>
                <c:f>graph!$K$41:$K$55</c:f>
                <c:numCache>
                  <c:formatCode>General</c:formatCode>
                  <c:ptCount val="15"/>
                  <c:pt idx="0">
                    <c:v>2.9151922459082096</c:v>
                  </c:pt>
                  <c:pt idx="1">
                    <c:v>3.5434427583863455</c:v>
                  </c:pt>
                  <c:pt idx="2">
                    <c:v>2.1278575558006176</c:v>
                  </c:pt>
                  <c:pt idx="3">
                    <c:v>3.4943288040166922</c:v>
                  </c:pt>
                  <c:pt idx="4">
                    <c:v>10.731296538996578</c:v>
                  </c:pt>
                  <c:pt idx="5">
                    <c:v>4.8877907815604065</c:v>
                  </c:pt>
                  <c:pt idx="6">
                    <c:v>0.92432924870260202</c:v>
                  </c:pt>
                  <c:pt idx="7">
                    <c:v>1.9908629972056073</c:v>
                  </c:pt>
                  <c:pt idx="8">
                    <c:v>0.49538028452885857</c:v>
                  </c:pt>
                  <c:pt idx="9">
                    <c:v>2.2205779584216336</c:v>
                  </c:pt>
                  <c:pt idx="10">
                    <c:v>3.6977562181983057</c:v>
                  </c:pt>
                  <c:pt idx="11">
                    <c:v>0.67923561081132611</c:v>
                  </c:pt>
                  <c:pt idx="12">
                    <c:v>1.5229953200209505</c:v>
                  </c:pt>
                  <c:pt idx="13">
                    <c:v>0</c:v>
                  </c:pt>
                  <c:pt idx="14">
                    <c:v>2.1170243765827528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41:$J$55</c:f>
              <c:numCache>
                <c:formatCode>0.0</c:formatCode>
                <c:ptCount val="15"/>
                <c:pt idx="0">
                  <c:v>44.745484400656814</c:v>
                </c:pt>
                <c:pt idx="1">
                  <c:v>48.484848484848492</c:v>
                </c:pt>
                <c:pt idx="2">
                  <c:v>31.5</c:v>
                </c:pt>
                <c:pt idx="3">
                  <c:v>40.345679012345677</c:v>
                </c:pt>
                <c:pt idx="4">
                  <c:v>42.92282430213465</c:v>
                </c:pt>
                <c:pt idx="5">
                  <c:v>43.684710351377021</c:v>
                </c:pt>
                <c:pt idx="6">
                  <c:v>54.638752052545158</c:v>
                </c:pt>
                <c:pt idx="7">
                  <c:v>54.022988505747129</c:v>
                </c:pt>
                <c:pt idx="8">
                  <c:v>36.283550757234963</c:v>
                </c:pt>
                <c:pt idx="9">
                  <c:v>60.256410256410255</c:v>
                </c:pt>
                <c:pt idx="10">
                  <c:v>34.440227703984817</c:v>
                </c:pt>
                <c:pt idx="11">
                  <c:v>40.392156862745104</c:v>
                </c:pt>
                <c:pt idx="12">
                  <c:v>40.998217468805706</c:v>
                </c:pt>
                <c:pt idx="13">
                  <c:v>26.666666666666668</c:v>
                </c:pt>
                <c:pt idx="14">
                  <c:v>33.3557347670250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DBC7-4104-9E90-F5BD90071796}"/>
            </c:ext>
          </c:extLst>
        </c:ser>
        <c:ser>
          <c:idx val="7"/>
          <c:order val="4"/>
          <c:tx>
            <c:strRef>
              <c:f>graph!$L$40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M$41:$M$55</c:f>
                <c:numCache>
                  <c:formatCode>General</c:formatCode>
                  <c:ptCount val="15"/>
                  <c:pt idx="0">
                    <c:v>4.9878114277730878</c:v>
                  </c:pt>
                  <c:pt idx="1">
                    <c:v>4.768459348299646</c:v>
                  </c:pt>
                  <c:pt idx="2">
                    <c:v>3.521100417220183</c:v>
                  </c:pt>
                  <c:pt idx="3">
                    <c:v>6.1447261040229657</c:v>
                  </c:pt>
                  <c:pt idx="4">
                    <c:v>18.975835804298072</c:v>
                  </c:pt>
                  <c:pt idx="5">
                    <c:v>2.0262666945253538</c:v>
                  </c:pt>
                  <c:pt idx="6">
                    <c:v>1.9237068167257771</c:v>
                  </c:pt>
                  <c:pt idx="7">
                    <c:v>0</c:v>
                  </c:pt>
                  <c:pt idx="8">
                    <c:v>3.437550946588289</c:v>
                  </c:pt>
                  <c:pt idx="9">
                    <c:v>0</c:v>
                  </c:pt>
                  <c:pt idx="10">
                    <c:v>5.2913057399970596</c:v>
                  </c:pt>
                  <c:pt idx="11">
                    <c:v>1.874031225061932</c:v>
                  </c:pt>
                  <c:pt idx="12">
                    <c:v>2.7672325661782597</c:v>
                  </c:pt>
                  <c:pt idx="13">
                    <c:v>1.9245008972987498</c:v>
                  </c:pt>
                  <c:pt idx="14">
                    <c:v>3.0621596336507562</c:v>
                  </c:pt>
                </c:numCache>
              </c:numRef>
            </c:plus>
            <c:minus>
              <c:numRef>
                <c:f>graph!$M$41:$M$55</c:f>
                <c:numCache>
                  <c:formatCode>General</c:formatCode>
                  <c:ptCount val="15"/>
                  <c:pt idx="0">
                    <c:v>4.9878114277730878</c:v>
                  </c:pt>
                  <c:pt idx="1">
                    <c:v>4.768459348299646</c:v>
                  </c:pt>
                  <c:pt idx="2">
                    <c:v>3.521100417220183</c:v>
                  </c:pt>
                  <c:pt idx="3">
                    <c:v>6.1447261040229657</c:v>
                  </c:pt>
                  <c:pt idx="4">
                    <c:v>18.975835804298072</c:v>
                  </c:pt>
                  <c:pt idx="5">
                    <c:v>2.0262666945253538</c:v>
                  </c:pt>
                  <c:pt idx="6">
                    <c:v>1.9237068167257771</c:v>
                  </c:pt>
                  <c:pt idx="7">
                    <c:v>0</c:v>
                  </c:pt>
                  <c:pt idx="8">
                    <c:v>3.437550946588289</c:v>
                  </c:pt>
                  <c:pt idx="9">
                    <c:v>0</c:v>
                  </c:pt>
                  <c:pt idx="10">
                    <c:v>5.2913057399970596</c:v>
                  </c:pt>
                  <c:pt idx="11">
                    <c:v>1.874031225061932</c:v>
                  </c:pt>
                  <c:pt idx="12">
                    <c:v>2.7672325661782597</c:v>
                  </c:pt>
                  <c:pt idx="13">
                    <c:v>1.9245008972987498</c:v>
                  </c:pt>
                  <c:pt idx="14">
                    <c:v>3.0621596336507562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41:$L$55</c:f>
              <c:numCache>
                <c:formatCode>0.0</c:formatCode>
                <c:ptCount val="15"/>
                <c:pt idx="0">
                  <c:v>81.239737274220033</c:v>
                </c:pt>
                <c:pt idx="1">
                  <c:v>109.37950937950937</c:v>
                </c:pt>
                <c:pt idx="2">
                  <c:v>71.277777777777786</c:v>
                </c:pt>
                <c:pt idx="3">
                  <c:v>94.76543209876543</c:v>
                </c:pt>
                <c:pt idx="4">
                  <c:v>88.144499178981945</c:v>
                </c:pt>
                <c:pt idx="5">
                  <c:v>87.511870845204157</c:v>
                </c:pt>
                <c:pt idx="6">
                  <c:v>91.871921182266007</c:v>
                </c:pt>
                <c:pt idx="7">
                  <c:v>93.103448275862078</c:v>
                </c:pt>
                <c:pt idx="8">
                  <c:v>77.054281001649429</c:v>
                </c:pt>
                <c:pt idx="9">
                  <c:v>96.153846153846146</c:v>
                </c:pt>
                <c:pt idx="10">
                  <c:v>79.348513598987992</c:v>
                </c:pt>
                <c:pt idx="11">
                  <c:v>77.871148459383747</c:v>
                </c:pt>
                <c:pt idx="12">
                  <c:v>85.026737967914457</c:v>
                </c:pt>
                <c:pt idx="13">
                  <c:v>88.8888888888889</c:v>
                </c:pt>
                <c:pt idx="14">
                  <c:v>73.1698028673834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DBC7-4104-9E90-F5BD90071796}"/>
            </c:ext>
          </c:extLst>
        </c:ser>
        <c:ser>
          <c:idx val="11"/>
          <c:order val="5"/>
          <c:tx>
            <c:strRef>
              <c:f>graph!$N$40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O$41:$O$55</c:f>
                <c:numCache>
                  <c:formatCode>General</c:formatCode>
                  <c:ptCount val="15"/>
                  <c:pt idx="0">
                    <c:v>3.5777928685551581</c:v>
                  </c:pt>
                  <c:pt idx="1">
                    <c:v>2.7492869961410817</c:v>
                  </c:pt>
                  <c:pt idx="2">
                    <c:v>2.2047927592204957</c:v>
                  </c:pt>
                  <c:pt idx="3">
                    <c:v>6.2439362445692996</c:v>
                  </c:pt>
                  <c:pt idx="4">
                    <c:v>21.563449777611364</c:v>
                  </c:pt>
                  <c:pt idx="5">
                    <c:v>2.0262666945253538</c:v>
                  </c:pt>
                  <c:pt idx="6">
                    <c:v>1.9197607473054017</c:v>
                  </c:pt>
                  <c:pt idx="7">
                    <c:v>0</c:v>
                  </c:pt>
                  <c:pt idx="8">
                    <c:v>2.3916864206090516</c:v>
                  </c:pt>
                  <c:pt idx="9">
                    <c:v>0</c:v>
                  </c:pt>
                  <c:pt idx="10">
                    <c:v>3.8589655307592889</c:v>
                  </c:pt>
                  <c:pt idx="11">
                    <c:v>4.1358996355968412</c:v>
                  </c:pt>
                  <c:pt idx="12">
                    <c:v>1.5437172972984718</c:v>
                  </c:pt>
                  <c:pt idx="13">
                    <c:v>3.3333333333333357</c:v>
                  </c:pt>
                  <c:pt idx="14">
                    <c:v>3.145505908883889</c:v>
                  </c:pt>
                </c:numCache>
              </c:numRef>
            </c:plus>
            <c:minus>
              <c:numRef>
                <c:f>graph!$O$41:$O$55</c:f>
                <c:numCache>
                  <c:formatCode>General</c:formatCode>
                  <c:ptCount val="15"/>
                  <c:pt idx="0">
                    <c:v>3.5777928685551581</c:v>
                  </c:pt>
                  <c:pt idx="1">
                    <c:v>2.7492869961410817</c:v>
                  </c:pt>
                  <c:pt idx="2">
                    <c:v>2.2047927592204957</c:v>
                  </c:pt>
                  <c:pt idx="3">
                    <c:v>6.2439362445692996</c:v>
                  </c:pt>
                  <c:pt idx="4">
                    <c:v>21.563449777611364</c:v>
                  </c:pt>
                  <c:pt idx="5">
                    <c:v>2.0262666945253538</c:v>
                  </c:pt>
                  <c:pt idx="6">
                    <c:v>1.9197607473054017</c:v>
                  </c:pt>
                  <c:pt idx="7">
                    <c:v>0</c:v>
                  </c:pt>
                  <c:pt idx="8">
                    <c:v>2.3916864206090516</c:v>
                  </c:pt>
                  <c:pt idx="9">
                    <c:v>0</c:v>
                  </c:pt>
                  <c:pt idx="10">
                    <c:v>3.8589655307592889</c:v>
                  </c:pt>
                  <c:pt idx="11">
                    <c:v>4.1358996355968412</c:v>
                  </c:pt>
                  <c:pt idx="12">
                    <c:v>1.5437172972984718</c:v>
                  </c:pt>
                  <c:pt idx="13">
                    <c:v>3.3333333333333357</c:v>
                  </c:pt>
                  <c:pt idx="14">
                    <c:v>3.145505908883889</c:v>
                  </c:pt>
                </c:numCache>
              </c:numRef>
            </c:minus>
          </c:errBars>
          <c:cat>
            <c:strRef>
              <c:f>graph!$C$41:$C$55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N$41:$N$55</c:f>
              <c:numCache>
                <c:formatCode>General</c:formatCode>
                <c:ptCount val="15"/>
                <c:pt idx="0">
                  <c:v>89.408866995073893</c:v>
                </c:pt>
                <c:pt idx="1">
                  <c:v>101.58730158730158</c:v>
                </c:pt>
                <c:pt idx="2">
                  <c:v>80.833333333333329</c:v>
                </c:pt>
                <c:pt idx="3">
                  <c:v>92.395061728395049</c:v>
                </c:pt>
                <c:pt idx="4">
                  <c:v>100.16420361247947</c:v>
                </c:pt>
                <c:pt idx="5">
                  <c:v>87.511870845204157</c:v>
                </c:pt>
                <c:pt idx="6">
                  <c:v>94.21182266009852</c:v>
                </c:pt>
                <c:pt idx="7">
                  <c:v>96.551724137931032</c:v>
                </c:pt>
                <c:pt idx="8">
                  <c:v>80.589293747188478</c:v>
                </c:pt>
                <c:pt idx="9">
                  <c:v>96.153846153846146</c:v>
                </c:pt>
                <c:pt idx="10">
                  <c:v>83.459835547122069</c:v>
                </c:pt>
                <c:pt idx="11">
                  <c:v>80.812324929971979</c:v>
                </c:pt>
                <c:pt idx="12">
                  <c:v>90.017825311942957</c:v>
                </c:pt>
                <c:pt idx="13">
                  <c:v>93.333333333333329</c:v>
                </c:pt>
                <c:pt idx="14">
                  <c:v>76.3978494623655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DBC7-4104-9E90-F5BD90071796}"/>
            </c:ext>
          </c:extLst>
        </c:ser>
        <c:ser>
          <c:idx val="0"/>
          <c:order val="6"/>
          <c:tx>
            <c:strRef>
              <c:f>graph!$P$40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P$41:$P$55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5EE-4EA4-B1F6-4D2FAAA280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0152088"/>
        <c:axId val="350600960"/>
      </c:barChart>
      <c:catAx>
        <c:axId val="350152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/>
            </a:pPr>
            <a:endParaRPr lang="it-IT"/>
          </a:p>
        </c:txPr>
        <c:crossAx val="350600960"/>
        <c:crosses val="autoZero"/>
        <c:auto val="1"/>
        <c:lblAlgn val="ctr"/>
        <c:lblOffset val="100"/>
        <c:noMultiLvlLbl val="0"/>
      </c:catAx>
      <c:valAx>
        <c:axId val="350600960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Colony diameter (% relativo to control)</a:t>
                </a:r>
              </a:p>
            </c:rich>
          </c:tx>
          <c:layout>
            <c:manualLayout>
              <c:xMode val="edge"/>
              <c:yMode val="edge"/>
              <c:x val="2.7127839945744322E-3"/>
              <c:y val="0.31946099415978935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>
                <a:lumMod val="50000"/>
                <a:lumOff val="50000"/>
              </a:schemeClr>
            </a:solidFill>
          </a:ln>
        </c:spPr>
        <c:crossAx val="3501520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93209409474703231"/>
          <c:y val="0.41143565873560195"/>
          <c:w val="6.7905854102077931E-2"/>
          <c:h val="0.2706666579530379"/>
        </c:manualLayout>
      </c:layout>
      <c:overlay val="0"/>
    </c:legend>
    <c:plotVisOnly val="1"/>
    <c:dispBlanksAs val="gap"/>
    <c:showDLblsOverMax val="0"/>
  </c:chart>
  <c:spPr>
    <a:ln>
      <a:solidFill>
        <a:schemeClr val="bg1"/>
      </a:solidFill>
    </a:ln>
  </c:spPr>
  <c:txPr>
    <a:bodyPr/>
    <a:lstStyle/>
    <a:p>
      <a:pPr>
        <a:defRPr sz="800"/>
      </a:pPr>
      <a:endParaRPr lang="it-IT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085</cdr:x>
      <cdr:y>0.13305</cdr:y>
    </cdr:from>
    <cdr:to>
      <cdr:x>0.10478</cdr:x>
      <cdr:y>0.16362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780902" y="1267301"/>
          <a:ext cx="231124" cy="2911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3785</cdr:x>
      <cdr:y>0.65039</cdr:y>
    </cdr:from>
    <cdr:to>
      <cdr:x>0.06698</cdr:x>
      <cdr:y>0.69683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365536" y="6194966"/>
          <a:ext cx="281348" cy="4423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4595</cdr:x>
      <cdr:y>0.62374</cdr:y>
    </cdr:from>
    <cdr:to>
      <cdr:x>0.07508</cdr:x>
      <cdr:y>0.6883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443815" y="5941125"/>
          <a:ext cx="281348" cy="6149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5334</cdr:x>
      <cdr:y>0.54434</cdr:y>
    </cdr:from>
    <cdr:to>
      <cdr:x>0.06999</cdr:x>
      <cdr:y>0.56812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515167" y="5184840"/>
          <a:ext cx="160812" cy="2265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6063</cdr:x>
      <cdr:y>0.50004</cdr:y>
    </cdr:from>
    <cdr:to>
      <cdr:x>0.07936</cdr:x>
      <cdr:y>0.52948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585576" y="4762882"/>
          <a:ext cx="180901" cy="2804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6588</cdr:x>
      <cdr:y>0.22937</cdr:y>
    </cdr:from>
    <cdr:to>
      <cdr:x>0.08773</cdr:x>
      <cdr:y>0.26561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636320" y="2184750"/>
          <a:ext cx="211034" cy="345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7218</cdr:x>
      <cdr:y>0.18007</cdr:y>
    </cdr:from>
    <cdr:to>
      <cdr:x>0.09196</cdr:x>
      <cdr:y>0.21857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697107" y="1715167"/>
          <a:ext cx="191042" cy="3667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9677</cdr:x>
      <cdr:y>0.12458</cdr:y>
    </cdr:from>
    <cdr:to>
      <cdr:x>0.13319</cdr:x>
      <cdr:y>0.15402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885825" y="1047750"/>
          <a:ext cx="333375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9748</cdr:x>
      <cdr:y>0.79696</cdr:y>
    </cdr:from>
    <cdr:to>
      <cdr:x>0.11517</cdr:x>
      <cdr:y>0.8298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941491" y="7591046"/>
          <a:ext cx="170856" cy="3128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1156</cdr:x>
      <cdr:y>0.64979</cdr:y>
    </cdr:from>
    <cdr:to>
      <cdr:x>0.13238</cdr:x>
      <cdr:y>0.68943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077439" y="6189251"/>
          <a:ext cx="201087" cy="3775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189</cdr:x>
      <cdr:y>0.46806</cdr:y>
    </cdr:from>
    <cdr:to>
      <cdr:x>0.14075</cdr:x>
      <cdr:y>0.50543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148368" y="4458272"/>
          <a:ext cx="211035" cy="355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2519</cdr:x>
      <cdr:y>0.03358</cdr:y>
    </cdr:from>
    <cdr:to>
      <cdr:x>0.15537</cdr:x>
      <cdr:y>0.06642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209156" y="319850"/>
          <a:ext cx="291489" cy="3128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3462</cdr:x>
      <cdr:y>0.09979</cdr:y>
    </cdr:from>
    <cdr:to>
      <cdr:x>0.15335</cdr:x>
      <cdr:y>0.13377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1300175" y="950500"/>
          <a:ext cx="180901" cy="3236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4223</cdr:x>
      <cdr:y>0.13118</cdr:y>
    </cdr:from>
    <cdr:to>
      <cdr:x>0.162</cdr:x>
      <cdr:y>0.16742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1373702" y="1249490"/>
          <a:ext cx="190946" cy="345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586</cdr:x>
      <cdr:y>0.70475</cdr:y>
    </cdr:from>
    <cdr:to>
      <cdr:x>0.17317</cdr:x>
      <cdr:y>0.7342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1531819" y="6712745"/>
          <a:ext cx="140722" cy="2805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16469</cdr:x>
      <cdr:y>0.66625</cdr:y>
    </cdr:from>
    <cdr:to>
      <cdr:x>0.18342</cdr:x>
      <cdr:y>0.69796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1590624" y="6346033"/>
          <a:ext cx="180901" cy="3020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16901</cdr:x>
      <cdr:y>0.57784</cdr:y>
    </cdr:from>
    <cdr:to>
      <cdr:x>0.19294</cdr:x>
      <cdr:y>0.59936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1632362" y="5503927"/>
          <a:ext cx="231124" cy="2049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7826</cdr:x>
      <cdr:y>0.5977</cdr:y>
    </cdr:from>
    <cdr:to>
      <cdr:x>0.19699</cdr:x>
      <cdr:y>0.63733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1721725" y="5693094"/>
          <a:ext cx="180901" cy="3774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8639</cdr:x>
      <cdr:y>0.308</cdr:y>
    </cdr:from>
    <cdr:to>
      <cdr:x>0.20308</cdr:x>
      <cdr:y>0.34962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1800225" y="2933702"/>
          <a:ext cx="161206" cy="3964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9179</cdr:x>
      <cdr:y>0.25175</cdr:y>
    </cdr:from>
    <cdr:to>
      <cdr:x>0.21781</cdr:x>
      <cdr:y>0.28799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1852402" y="2397919"/>
          <a:ext cx="251311" cy="345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9951</cdr:x>
      <cdr:y>0.132</cdr:y>
    </cdr:from>
    <cdr:to>
      <cdr:x>0.22969</cdr:x>
      <cdr:y>0.17277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1926969" y="1257300"/>
          <a:ext cx="291489" cy="3883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598</cdr:x>
      <cdr:y>0.763</cdr:y>
    </cdr:from>
    <cdr:to>
      <cdr:x>0.23846</cdr:x>
      <cdr:y>0.79462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085975" y="7267577"/>
          <a:ext cx="217169" cy="3011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2274</cdr:x>
      <cdr:y>0.74867</cdr:y>
    </cdr:from>
    <cdr:to>
      <cdr:x>0.26124</cdr:x>
      <cdr:y>0.7951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151338" y="7131083"/>
          <a:ext cx="371846" cy="4422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3654</cdr:x>
      <cdr:y>0.52695</cdr:y>
    </cdr:from>
    <cdr:to>
      <cdr:x>0.25943</cdr:x>
      <cdr:y>0.57452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2284614" y="5019200"/>
          <a:ext cx="221079" cy="4531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4164</cdr:x>
      <cdr:y>0.107</cdr:y>
    </cdr:from>
    <cdr:to>
      <cdr:x>0.2712</cdr:x>
      <cdr:y>0.157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2333798" y="1019178"/>
          <a:ext cx="285577" cy="4762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    a</a:t>
          </a:r>
        </a:p>
      </cdr:txBody>
    </cdr:sp>
  </cdr:relSizeAnchor>
  <cdr:relSizeAnchor xmlns:cdr="http://schemas.openxmlformats.org/drawingml/2006/chartDrawing">
    <cdr:from>
      <cdr:x>0.28205</cdr:x>
      <cdr:y>0.735</cdr:y>
    </cdr:from>
    <cdr:to>
      <cdr:x>0.30494</cdr:x>
      <cdr:y>0.76225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2724151" y="7000877"/>
          <a:ext cx="221104" cy="2595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906</cdr:x>
      <cdr:y>0.58424</cdr:y>
    </cdr:from>
    <cdr:to>
      <cdr:x>0.3062</cdr:x>
      <cdr:y>0.61709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2806707" y="5704058"/>
          <a:ext cx="150670" cy="3207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9487</cdr:x>
      <cdr:y>0.45756</cdr:y>
    </cdr:from>
    <cdr:to>
      <cdr:x>0.32362</cdr:x>
      <cdr:y>0.51098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2847976" y="4467228"/>
          <a:ext cx="277660" cy="5215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0412</cdr:x>
      <cdr:y>0.08028</cdr:y>
    </cdr:from>
    <cdr:to>
      <cdr:x>0.32598</cdr:x>
      <cdr:y>0.10859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2937288" y="783832"/>
          <a:ext cx="211132" cy="2763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0521</cdr:x>
      <cdr:y>0</cdr:y>
    </cdr:from>
    <cdr:to>
      <cdr:x>0.32915</cdr:x>
      <cdr:y>0.02718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2947852" y="0"/>
          <a:ext cx="231221" cy="265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1825</cdr:x>
      <cdr:y>0.12879</cdr:y>
    </cdr:from>
    <cdr:to>
      <cdr:x>0.34738</cdr:x>
      <cdr:y>0.16163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073779" y="1257405"/>
          <a:ext cx="281347" cy="320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4679</cdr:x>
      <cdr:y>0.70247</cdr:y>
    </cdr:from>
    <cdr:to>
      <cdr:x>0.3676</cdr:x>
      <cdr:y>0.74324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349410" y="6858293"/>
          <a:ext cx="200990" cy="398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714</cdr:x>
      <cdr:y>0.4933</cdr:y>
    </cdr:from>
    <cdr:to>
      <cdr:x>0.37899</cdr:x>
      <cdr:y>0.53407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449337" y="4816120"/>
          <a:ext cx="211035" cy="398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6043</cdr:x>
      <cdr:y>0.20732</cdr:y>
    </cdr:from>
    <cdr:to>
      <cdr:x>0.40517</cdr:x>
      <cdr:y>0.24809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3481127" y="2024077"/>
          <a:ext cx="432114" cy="398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</a:t>
          </a:r>
          <a:r>
            <a:rPr lang="fr-FR" sz="1100"/>
            <a:t> </a:t>
          </a:r>
        </a:p>
      </cdr:txBody>
    </cdr:sp>
  </cdr:relSizeAnchor>
  <cdr:relSizeAnchor xmlns:cdr="http://schemas.openxmlformats.org/drawingml/2006/chartDrawing">
    <cdr:from>
      <cdr:x>0.37559</cdr:x>
      <cdr:y>0.13194</cdr:y>
    </cdr:from>
    <cdr:to>
      <cdr:x>0.40473</cdr:x>
      <cdr:y>0.16026</cdr:y>
    </cdr:to>
    <cdr:sp macro="" textlink="">
      <cdr:nvSpPr>
        <cdr:cNvPr id="36" name="CasellaDiTesto 35"/>
        <cdr:cNvSpPr txBox="1"/>
      </cdr:nvSpPr>
      <cdr:spPr>
        <a:xfrm xmlns:a="http://schemas.openxmlformats.org/drawingml/2006/main">
          <a:off x="3627565" y="1288157"/>
          <a:ext cx="281445" cy="2764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476</cdr:x>
      <cdr:y>0.61725</cdr:y>
    </cdr:from>
    <cdr:to>
      <cdr:x>0.41662</cdr:x>
      <cdr:y>0.64669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3812698" y="6026284"/>
          <a:ext cx="211131" cy="2874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f</a:t>
          </a:r>
        </a:p>
      </cdr:txBody>
    </cdr:sp>
  </cdr:relSizeAnchor>
  <cdr:relSizeAnchor xmlns:cdr="http://schemas.openxmlformats.org/drawingml/2006/chartDrawing">
    <cdr:from>
      <cdr:x>0.40039</cdr:x>
      <cdr:y>0.52488</cdr:y>
    </cdr:from>
    <cdr:to>
      <cdr:x>0.42352</cdr:x>
      <cdr:y>0.5504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3867150" y="5124452"/>
          <a:ext cx="223354" cy="2491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0714</cdr:x>
      <cdr:y>0.47663</cdr:y>
    </cdr:from>
    <cdr:to>
      <cdr:x>0.42587</cdr:x>
      <cdr:y>0.50494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3932291" y="4653357"/>
          <a:ext cx="180901" cy="2763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41448</cdr:x>
      <cdr:y>0.44347</cdr:y>
    </cdr:from>
    <cdr:to>
      <cdr:x>0.43425</cdr:x>
      <cdr:y>0.47858</cdr:y>
    </cdr:to>
    <cdr:sp macro="" textlink="">
      <cdr:nvSpPr>
        <cdr:cNvPr id="40" name="CasellaDiTesto 39"/>
        <cdr:cNvSpPr txBox="1"/>
      </cdr:nvSpPr>
      <cdr:spPr>
        <a:xfrm xmlns:a="http://schemas.openxmlformats.org/drawingml/2006/main">
          <a:off x="4003220" y="4329623"/>
          <a:ext cx="190946" cy="3427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2155</cdr:x>
      <cdr:y>0.17491</cdr:y>
    </cdr:from>
    <cdr:to>
      <cdr:x>0.44964</cdr:x>
      <cdr:y>0.22021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4071454" y="1707693"/>
          <a:ext cx="271303" cy="4422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2899</cdr:x>
      <cdr:y>0.16007</cdr:y>
    </cdr:from>
    <cdr:to>
      <cdr:x>0.44876</cdr:x>
      <cdr:y>0.19291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4143326" y="1562758"/>
          <a:ext cx="190946" cy="320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3687</cdr:x>
      <cdr:y>0.13128</cdr:y>
    </cdr:from>
    <cdr:to>
      <cdr:x>0.45977</cdr:x>
      <cdr:y>0.15393</cdr:y>
    </cdr:to>
    <cdr:sp macro="" textlink="">
      <cdr:nvSpPr>
        <cdr:cNvPr id="43" name="CasellaDiTesto 42"/>
        <cdr:cNvSpPr txBox="1"/>
      </cdr:nvSpPr>
      <cdr:spPr>
        <a:xfrm xmlns:a="http://schemas.openxmlformats.org/drawingml/2006/main">
          <a:off x="4219452" y="1281744"/>
          <a:ext cx="221176" cy="2211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5314</cdr:x>
      <cdr:y>0.53816</cdr:y>
    </cdr:from>
    <cdr:to>
      <cdr:x>0.46979</cdr:x>
      <cdr:y>0.56987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4376626" y="5254154"/>
          <a:ext cx="160811" cy="3095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6055</cdr:x>
      <cdr:y>0.49854</cdr:y>
    </cdr:from>
    <cdr:to>
      <cdr:x>0.48179</cdr:x>
      <cdr:y>0.53184</cdr:y>
    </cdr:to>
    <cdr:sp macro="" textlink="">
      <cdr:nvSpPr>
        <cdr:cNvPr id="45" name="CasellaDiTesto 44"/>
        <cdr:cNvSpPr txBox="1"/>
      </cdr:nvSpPr>
      <cdr:spPr>
        <a:xfrm xmlns:a="http://schemas.openxmlformats.org/drawingml/2006/main">
          <a:off x="4448175" y="4867279"/>
          <a:ext cx="205121" cy="3251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4693</cdr:x>
      <cdr:y>0.4598</cdr:y>
    </cdr:from>
    <cdr:to>
      <cdr:x>0.49011</cdr:x>
      <cdr:y>0.48471</cdr:y>
    </cdr:to>
    <cdr:sp macro="" textlink="">
      <cdr:nvSpPr>
        <cdr:cNvPr id="46" name="CasellaDiTesto 45"/>
        <cdr:cNvSpPr txBox="1"/>
      </cdr:nvSpPr>
      <cdr:spPr>
        <a:xfrm xmlns:a="http://schemas.openxmlformats.org/drawingml/2006/main">
          <a:off x="4295775" y="3867150"/>
          <a:ext cx="190500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7473</cdr:x>
      <cdr:y>0.44124</cdr:y>
    </cdr:from>
    <cdr:to>
      <cdr:x>0.4945</cdr:x>
      <cdr:y>0.46956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4585062" y="4307844"/>
          <a:ext cx="190946" cy="2764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8201</cdr:x>
      <cdr:y>0.18026</cdr:y>
    </cdr:from>
    <cdr:to>
      <cdr:x>0.50178</cdr:x>
      <cdr:y>0.2063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4655375" y="1759937"/>
          <a:ext cx="190946" cy="2542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8535</cdr:x>
      <cdr:y>0.13863</cdr:y>
    </cdr:from>
    <cdr:to>
      <cdr:x>0.52905</cdr:x>
      <cdr:y>0.18393</cdr:y>
    </cdr:to>
    <cdr:sp macro="" textlink="">
      <cdr:nvSpPr>
        <cdr:cNvPr id="49" name="CasellaDiTesto 48"/>
        <cdr:cNvSpPr txBox="1"/>
      </cdr:nvSpPr>
      <cdr:spPr>
        <a:xfrm xmlns:a="http://schemas.openxmlformats.org/drawingml/2006/main" rot="16200000">
          <a:off x="4677586" y="1363593"/>
          <a:ext cx="442270" cy="4220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51245</cdr:x>
      <cdr:y>0.64345</cdr:y>
    </cdr:from>
    <cdr:to>
      <cdr:x>0.53118</cdr:x>
      <cdr:y>0.6695</cdr:y>
    </cdr:to>
    <cdr:sp macro="" textlink="">
      <cdr:nvSpPr>
        <cdr:cNvPr id="50" name="CasellaDiTesto 49"/>
        <cdr:cNvSpPr txBox="1"/>
      </cdr:nvSpPr>
      <cdr:spPr>
        <a:xfrm xmlns:a="http://schemas.openxmlformats.org/drawingml/2006/main">
          <a:off x="4949463" y="6282120"/>
          <a:ext cx="180901" cy="2543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9526</cdr:x>
      <cdr:y>0.13141</cdr:y>
    </cdr:from>
    <cdr:to>
      <cdr:x>0.51711</cdr:x>
      <cdr:y>0.15292</cdr:y>
    </cdr:to>
    <cdr:sp macro="" textlink="">
      <cdr:nvSpPr>
        <cdr:cNvPr id="51" name="CasellaDiTesto 50"/>
        <cdr:cNvSpPr txBox="1"/>
      </cdr:nvSpPr>
      <cdr:spPr>
        <a:xfrm xmlns:a="http://schemas.openxmlformats.org/drawingml/2006/main">
          <a:off x="4783380" y="1282965"/>
          <a:ext cx="211035" cy="2100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1703</cdr:x>
      <cdr:y>0.59903</cdr:y>
    </cdr:from>
    <cdr:to>
      <cdr:x>0.55554</cdr:x>
      <cdr:y>0.6466</cdr:y>
    </cdr:to>
    <cdr:sp macro="" textlink="">
      <cdr:nvSpPr>
        <cdr:cNvPr id="52" name="CasellaDiTesto 51"/>
        <cdr:cNvSpPr txBox="1"/>
      </cdr:nvSpPr>
      <cdr:spPr>
        <a:xfrm xmlns:a="http://schemas.openxmlformats.org/drawingml/2006/main" rot="16200000">
          <a:off x="4947381" y="5894674"/>
          <a:ext cx="464432" cy="3719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</a:t>
          </a:r>
        </a:p>
      </cdr:txBody>
    </cdr:sp>
  </cdr:relSizeAnchor>
  <cdr:relSizeAnchor xmlns:cdr="http://schemas.openxmlformats.org/drawingml/2006/chartDrawing">
    <cdr:from>
      <cdr:x>0.52681</cdr:x>
      <cdr:y>0.5443</cdr:y>
    </cdr:from>
    <cdr:to>
      <cdr:x>0.54554</cdr:x>
      <cdr:y>0.57714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5088106" y="5314032"/>
          <a:ext cx="180901" cy="3206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3254</cdr:x>
      <cdr:y>0.55455</cdr:y>
    </cdr:from>
    <cdr:to>
      <cdr:x>0.5648</cdr:x>
      <cdr:y>0.59645</cdr:y>
    </cdr:to>
    <cdr:sp macro="" textlink="">
      <cdr:nvSpPr>
        <cdr:cNvPr id="54" name="CasellaDiTesto 53"/>
        <cdr:cNvSpPr txBox="1"/>
      </cdr:nvSpPr>
      <cdr:spPr>
        <a:xfrm xmlns:a="http://schemas.openxmlformats.org/drawingml/2006/main" rot="16200000">
          <a:off x="5094751" y="5462868"/>
          <a:ext cx="409075" cy="3115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d</a:t>
          </a:r>
        </a:p>
      </cdr:txBody>
    </cdr:sp>
  </cdr:relSizeAnchor>
  <cdr:relSizeAnchor xmlns:cdr="http://schemas.openxmlformats.org/drawingml/2006/chartDrawing">
    <cdr:from>
      <cdr:x>0.54028</cdr:x>
      <cdr:y>0.27007</cdr:y>
    </cdr:from>
    <cdr:to>
      <cdr:x>0.55902</cdr:x>
      <cdr:y>0.30292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5218167" y="2636745"/>
          <a:ext cx="180998" cy="3207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4635</cdr:x>
      <cdr:y>0.24976</cdr:y>
    </cdr:from>
    <cdr:to>
      <cdr:x>0.57232</cdr:x>
      <cdr:y>0.27746</cdr:y>
    </cdr:to>
    <cdr:sp macro="" textlink="">
      <cdr:nvSpPr>
        <cdr:cNvPr id="56" name="CasellaDiTesto 55"/>
        <cdr:cNvSpPr txBox="1"/>
      </cdr:nvSpPr>
      <cdr:spPr>
        <a:xfrm xmlns:a="http://schemas.openxmlformats.org/drawingml/2006/main">
          <a:off x="5276850" y="2438403"/>
          <a:ext cx="250817" cy="2704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7988</cdr:x>
      <cdr:y>0.76</cdr:y>
    </cdr:from>
    <cdr:to>
      <cdr:x>0.60973</cdr:x>
      <cdr:y>0.79098</cdr:y>
    </cdr:to>
    <cdr:sp macro="" textlink="">
      <cdr:nvSpPr>
        <cdr:cNvPr id="57" name="CasellaDiTesto 56"/>
        <cdr:cNvSpPr txBox="1"/>
      </cdr:nvSpPr>
      <cdr:spPr>
        <a:xfrm xmlns:a="http://schemas.openxmlformats.org/drawingml/2006/main">
          <a:off x="5600700" y="7419979"/>
          <a:ext cx="288249" cy="302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8607</cdr:x>
      <cdr:y>0.51743</cdr:y>
    </cdr:from>
    <cdr:to>
      <cdr:x>0.60688</cdr:x>
      <cdr:y>0.54574</cdr:y>
    </cdr:to>
    <cdr:sp macro="" textlink="">
      <cdr:nvSpPr>
        <cdr:cNvPr id="58" name="CasellaDiTesto 57"/>
        <cdr:cNvSpPr txBox="1"/>
      </cdr:nvSpPr>
      <cdr:spPr>
        <a:xfrm xmlns:a="http://schemas.openxmlformats.org/drawingml/2006/main">
          <a:off x="5660423" y="5051783"/>
          <a:ext cx="200990" cy="2763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9521</cdr:x>
      <cdr:y>0.38958</cdr:y>
    </cdr:from>
    <cdr:to>
      <cdr:x>0.61915</cdr:x>
      <cdr:y>0.42922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5448300" y="3276600"/>
          <a:ext cx="21907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9856</cdr:x>
      <cdr:y>0.16069</cdr:y>
    </cdr:from>
    <cdr:to>
      <cdr:x>0.6381</cdr:x>
      <cdr:y>0.21052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5781056" y="1568885"/>
          <a:ext cx="381891" cy="4864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</a:t>
          </a:r>
        </a:p>
      </cdr:txBody>
    </cdr:sp>
  </cdr:relSizeAnchor>
  <cdr:relSizeAnchor xmlns:cdr="http://schemas.openxmlformats.org/drawingml/2006/chartDrawing">
    <cdr:from>
      <cdr:x>0.55555</cdr:x>
      <cdr:y>0.13156</cdr:y>
    </cdr:from>
    <cdr:to>
      <cdr:x>0.58469</cdr:x>
      <cdr:y>0.1644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5365742" y="1284473"/>
          <a:ext cx="281444" cy="320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3196</cdr:x>
      <cdr:y>0.78115</cdr:y>
    </cdr:from>
    <cdr:to>
      <cdr:x>0.64757</cdr:x>
      <cdr:y>0.81286</cdr:y>
    </cdr:to>
    <cdr:sp macro="" textlink="">
      <cdr:nvSpPr>
        <cdr:cNvPr id="62" name="CasellaDiTesto 61"/>
        <cdr:cNvSpPr txBox="1"/>
      </cdr:nvSpPr>
      <cdr:spPr>
        <a:xfrm xmlns:a="http://schemas.openxmlformats.org/drawingml/2006/main">
          <a:off x="6103718" y="7626472"/>
          <a:ext cx="150767" cy="3095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3708</cdr:x>
      <cdr:y>0.65463</cdr:y>
    </cdr:from>
    <cdr:to>
      <cdr:x>0.65978</cdr:x>
      <cdr:y>0.68715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6153150" y="6391278"/>
          <a:ext cx="219273" cy="31746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445</cdr:x>
      <cdr:y>0.56207</cdr:y>
    </cdr:from>
    <cdr:to>
      <cdr:x>0.70174</cdr:x>
      <cdr:y>0.61417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6224774" y="5487542"/>
          <a:ext cx="552844" cy="5086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 </a:t>
          </a:r>
        </a:p>
      </cdr:txBody>
    </cdr:sp>
  </cdr:relSizeAnchor>
  <cdr:relSizeAnchor xmlns:cdr="http://schemas.openxmlformats.org/drawingml/2006/chartDrawing">
    <cdr:from>
      <cdr:x>0.65584</cdr:x>
      <cdr:y>0.22169</cdr:y>
    </cdr:from>
    <cdr:to>
      <cdr:x>0.70267</cdr:x>
      <cdr:y>0.26699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6334323" y="2164393"/>
          <a:ext cx="452300" cy="4422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</a:t>
          </a:r>
        </a:p>
      </cdr:txBody>
    </cdr:sp>
  </cdr:relSizeAnchor>
  <cdr:relSizeAnchor xmlns:cdr="http://schemas.openxmlformats.org/drawingml/2006/chartDrawing">
    <cdr:from>
      <cdr:x>0.6147</cdr:x>
      <cdr:y>0.13127</cdr:y>
    </cdr:from>
    <cdr:to>
      <cdr:x>0.64904</cdr:x>
      <cdr:y>0.16071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5937020" y="1281575"/>
          <a:ext cx="331667" cy="2874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357</cdr:x>
      <cdr:y>0.13073</cdr:y>
    </cdr:from>
    <cdr:to>
      <cdr:x>0.70704</cdr:x>
      <cdr:y>0.16189</cdr:y>
    </cdr:to>
    <cdr:sp macro="" textlink="">
      <cdr:nvSpPr>
        <cdr:cNvPr id="67" name="CasellaDiTesto 66"/>
        <cdr:cNvSpPr txBox="1"/>
      </cdr:nvSpPr>
      <cdr:spPr>
        <a:xfrm xmlns:a="http://schemas.openxmlformats.org/drawingml/2006/main">
          <a:off x="6505576" y="1276353"/>
          <a:ext cx="323306" cy="3042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8925</cdr:x>
      <cdr:y>0.6381</cdr:y>
    </cdr:from>
    <cdr:to>
      <cdr:x>0.73504</cdr:x>
      <cdr:y>0.67321</cdr:y>
    </cdr:to>
    <cdr:sp macro="" textlink="">
      <cdr:nvSpPr>
        <cdr:cNvPr id="68" name="CasellaDiTesto 67"/>
        <cdr:cNvSpPr txBox="1"/>
      </cdr:nvSpPr>
      <cdr:spPr>
        <a:xfrm xmlns:a="http://schemas.openxmlformats.org/drawingml/2006/main">
          <a:off x="6656985" y="6229876"/>
          <a:ext cx="442256" cy="342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d</a:t>
          </a:r>
        </a:p>
      </cdr:txBody>
    </cdr:sp>
  </cdr:relSizeAnchor>
  <cdr:relSizeAnchor xmlns:cdr="http://schemas.openxmlformats.org/drawingml/2006/chartDrawing">
    <cdr:from>
      <cdr:x>0.70262</cdr:x>
      <cdr:y>0.54345</cdr:y>
    </cdr:from>
    <cdr:to>
      <cdr:x>0.75777</cdr:x>
      <cdr:y>0.57629</cdr:y>
    </cdr:to>
    <cdr:sp macro="" textlink="">
      <cdr:nvSpPr>
        <cdr:cNvPr id="69" name="CasellaDiTesto 68"/>
        <cdr:cNvSpPr txBox="1"/>
      </cdr:nvSpPr>
      <cdr:spPr>
        <a:xfrm xmlns:a="http://schemas.openxmlformats.org/drawingml/2006/main">
          <a:off x="6786104" y="5305729"/>
          <a:ext cx="532658" cy="320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71696</cdr:x>
      <cdr:y>0.27415</cdr:y>
    </cdr:from>
    <cdr:to>
      <cdr:x>0.73793</cdr:x>
      <cdr:y>0.30471</cdr:y>
    </cdr:to>
    <cdr:sp macro="" textlink="">
      <cdr:nvSpPr>
        <cdr:cNvPr id="70" name="CasellaDiTesto 69"/>
        <cdr:cNvSpPr txBox="1"/>
      </cdr:nvSpPr>
      <cdr:spPr>
        <a:xfrm xmlns:a="http://schemas.openxmlformats.org/drawingml/2006/main">
          <a:off x="6924675" y="2676528"/>
          <a:ext cx="202525" cy="2983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2556</cdr:x>
      <cdr:y>0.23934</cdr:y>
    </cdr:from>
    <cdr:to>
      <cdr:x>0.74637</cdr:x>
      <cdr:y>0.27332</cdr:y>
    </cdr:to>
    <cdr:sp macro="" textlink="">
      <cdr:nvSpPr>
        <cdr:cNvPr id="71" name="CasellaDiTesto 70"/>
        <cdr:cNvSpPr txBox="1"/>
      </cdr:nvSpPr>
      <cdr:spPr>
        <a:xfrm xmlns:a="http://schemas.openxmlformats.org/drawingml/2006/main">
          <a:off x="7007703" y="2336681"/>
          <a:ext cx="200990" cy="331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3245</cdr:x>
      <cdr:y>0.13109</cdr:y>
    </cdr:from>
    <cdr:to>
      <cdr:x>0.76263</cdr:x>
      <cdr:y>0.17186</cdr:y>
    </cdr:to>
    <cdr:sp macro="" textlink="">
      <cdr:nvSpPr>
        <cdr:cNvPr id="72" name="CasellaDiTesto 71"/>
        <cdr:cNvSpPr txBox="1"/>
      </cdr:nvSpPr>
      <cdr:spPr>
        <a:xfrm xmlns:a="http://schemas.openxmlformats.org/drawingml/2006/main">
          <a:off x="7074304" y="1279853"/>
          <a:ext cx="291489" cy="3980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5058</cdr:x>
      <cdr:y>0.69797</cdr:y>
    </cdr:from>
    <cdr:to>
      <cdr:x>0.76827</cdr:x>
      <cdr:y>0.72628</cdr:y>
    </cdr:to>
    <cdr:sp macro="" textlink="">
      <cdr:nvSpPr>
        <cdr:cNvPr id="73" name="CasellaDiTesto 72"/>
        <cdr:cNvSpPr txBox="1"/>
      </cdr:nvSpPr>
      <cdr:spPr>
        <a:xfrm xmlns:a="http://schemas.openxmlformats.org/drawingml/2006/main">
          <a:off x="7249392" y="6814351"/>
          <a:ext cx="170856" cy="2763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75891</cdr:x>
      <cdr:y>0.642</cdr:y>
    </cdr:from>
    <cdr:to>
      <cdr:x>0.77348</cdr:x>
      <cdr:y>0.67484</cdr:y>
    </cdr:to>
    <cdr:sp macro="" textlink="">
      <cdr:nvSpPr>
        <cdr:cNvPr id="74" name="CasellaDiTesto 73"/>
        <cdr:cNvSpPr txBox="1"/>
      </cdr:nvSpPr>
      <cdr:spPr>
        <a:xfrm xmlns:a="http://schemas.openxmlformats.org/drawingml/2006/main">
          <a:off x="7329846" y="6267976"/>
          <a:ext cx="140722" cy="320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6313</cdr:x>
      <cdr:y>0.56352</cdr:y>
    </cdr:from>
    <cdr:to>
      <cdr:x>0.78394</cdr:x>
      <cdr:y>0.5941</cdr:y>
    </cdr:to>
    <cdr:sp macro="" textlink="">
      <cdr:nvSpPr>
        <cdr:cNvPr id="75" name="CasellaDiTesto 74"/>
        <cdr:cNvSpPr txBox="1"/>
      </cdr:nvSpPr>
      <cdr:spPr>
        <a:xfrm xmlns:a="http://schemas.openxmlformats.org/drawingml/2006/main">
          <a:off x="7370544" y="5501687"/>
          <a:ext cx="200991" cy="2985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7035</cdr:x>
      <cdr:y>0.53536</cdr:y>
    </cdr:from>
    <cdr:to>
      <cdr:x>0.78909</cdr:x>
      <cdr:y>0.55574</cdr:y>
    </cdr:to>
    <cdr:sp macro="" textlink="">
      <cdr:nvSpPr>
        <cdr:cNvPr id="76" name="CasellaDiTesto 75"/>
        <cdr:cNvSpPr txBox="1"/>
      </cdr:nvSpPr>
      <cdr:spPr>
        <a:xfrm xmlns:a="http://schemas.openxmlformats.org/drawingml/2006/main">
          <a:off x="7440337" y="5226800"/>
          <a:ext cx="180998" cy="1989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7613</cdr:x>
      <cdr:y>0.21756</cdr:y>
    </cdr:from>
    <cdr:to>
      <cdr:x>0.79917</cdr:x>
      <cdr:y>0.23669</cdr:y>
    </cdr:to>
    <cdr:sp macro="" textlink="">
      <cdr:nvSpPr>
        <cdr:cNvPr id="77" name="CasellaDiTesto 76"/>
        <cdr:cNvSpPr txBox="1"/>
      </cdr:nvSpPr>
      <cdr:spPr>
        <a:xfrm xmlns:a="http://schemas.openxmlformats.org/drawingml/2006/main">
          <a:off x="7496175" y="2124078"/>
          <a:ext cx="222489" cy="1867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8394</cdr:x>
      <cdr:y>0.19045</cdr:y>
    </cdr:from>
    <cdr:to>
      <cdr:x>0.80475</cdr:x>
      <cdr:y>0.21989</cdr:y>
    </cdr:to>
    <cdr:sp macro="" textlink="">
      <cdr:nvSpPr>
        <cdr:cNvPr id="78" name="CasellaDiTesto 77"/>
        <cdr:cNvSpPr txBox="1"/>
      </cdr:nvSpPr>
      <cdr:spPr>
        <a:xfrm xmlns:a="http://schemas.openxmlformats.org/drawingml/2006/main">
          <a:off x="7571535" y="1859423"/>
          <a:ext cx="200990" cy="2874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0897</cdr:x>
      <cdr:y>0.63779</cdr:y>
    </cdr:from>
    <cdr:to>
      <cdr:x>0.82458</cdr:x>
      <cdr:y>0.68195</cdr:y>
    </cdr:to>
    <cdr:sp macro="" textlink="">
      <cdr:nvSpPr>
        <cdr:cNvPr id="79" name="CasellaDiTesto 78"/>
        <cdr:cNvSpPr txBox="1"/>
      </cdr:nvSpPr>
      <cdr:spPr>
        <a:xfrm xmlns:a="http://schemas.openxmlformats.org/drawingml/2006/main">
          <a:off x="7813320" y="6226861"/>
          <a:ext cx="150767" cy="4311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1361</cdr:x>
      <cdr:y>0.60683</cdr:y>
    </cdr:from>
    <cdr:to>
      <cdr:x>0.83767</cdr:x>
      <cdr:y>0.64779</cdr:y>
    </cdr:to>
    <cdr:sp macro="" textlink="">
      <cdr:nvSpPr>
        <cdr:cNvPr id="80" name="CasellaDiTesto 79"/>
        <cdr:cNvSpPr txBox="1"/>
      </cdr:nvSpPr>
      <cdr:spPr>
        <a:xfrm xmlns:a="http://schemas.openxmlformats.org/drawingml/2006/main">
          <a:off x="7858125" y="5924553"/>
          <a:ext cx="232386" cy="3999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2337</cdr:x>
      <cdr:y>0.52357</cdr:y>
    </cdr:from>
    <cdr:to>
      <cdr:x>0.84627</cdr:x>
      <cdr:y>0.55754</cdr:y>
    </cdr:to>
    <cdr:sp macro="" textlink="">
      <cdr:nvSpPr>
        <cdr:cNvPr id="81" name="CasellaDiTesto 80"/>
        <cdr:cNvSpPr txBox="1"/>
      </cdr:nvSpPr>
      <cdr:spPr>
        <a:xfrm xmlns:a="http://schemas.openxmlformats.org/drawingml/2006/main">
          <a:off x="7952386" y="5111662"/>
          <a:ext cx="221177" cy="3316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3477</cdr:x>
      <cdr:y>0.19741</cdr:y>
    </cdr:from>
    <cdr:to>
      <cdr:x>0.85974</cdr:x>
      <cdr:y>0.22345</cdr:y>
    </cdr:to>
    <cdr:sp macro="" textlink="">
      <cdr:nvSpPr>
        <cdr:cNvPr id="82" name="CasellaDiTesto 81"/>
        <cdr:cNvSpPr txBox="1"/>
      </cdr:nvSpPr>
      <cdr:spPr>
        <a:xfrm xmlns:a="http://schemas.openxmlformats.org/drawingml/2006/main">
          <a:off x="8062455" y="1927320"/>
          <a:ext cx="241169" cy="2542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4101</cdr:x>
      <cdr:y>0.13106</cdr:y>
    </cdr:from>
    <cdr:to>
      <cdr:x>0.892</cdr:x>
      <cdr:y>0.18428</cdr:y>
    </cdr:to>
    <cdr:sp macro="" textlink="">
      <cdr:nvSpPr>
        <cdr:cNvPr id="83" name="CasellaDiTesto 82"/>
        <cdr:cNvSpPr txBox="1"/>
      </cdr:nvSpPr>
      <cdr:spPr>
        <a:xfrm xmlns:a="http://schemas.openxmlformats.org/drawingml/2006/main" rot="16200000">
          <a:off x="8109167" y="1293124"/>
          <a:ext cx="519594" cy="4924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79186</cdr:x>
      <cdr:y>0.13311</cdr:y>
    </cdr:from>
    <cdr:to>
      <cdr:x>0.83348</cdr:x>
      <cdr:y>0.17841</cdr:y>
    </cdr:to>
    <cdr:sp macro="" textlink="">
      <cdr:nvSpPr>
        <cdr:cNvPr id="84" name="CasellaDiTesto 83"/>
        <cdr:cNvSpPr txBox="1"/>
      </cdr:nvSpPr>
      <cdr:spPr>
        <a:xfrm xmlns:a="http://schemas.openxmlformats.org/drawingml/2006/main">
          <a:off x="7648054" y="1299572"/>
          <a:ext cx="401981" cy="442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6823</cdr:x>
      <cdr:y>0.72257</cdr:y>
    </cdr:from>
    <cdr:to>
      <cdr:x>0.90985</cdr:x>
      <cdr:y>0.76221</cdr:y>
    </cdr:to>
    <cdr:sp macro="" textlink="">
      <cdr:nvSpPr>
        <cdr:cNvPr id="85" name="CasellaDiTesto 84"/>
        <cdr:cNvSpPr txBox="1"/>
      </cdr:nvSpPr>
      <cdr:spPr>
        <a:xfrm xmlns:a="http://schemas.openxmlformats.org/drawingml/2006/main">
          <a:off x="8385637" y="7054536"/>
          <a:ext cx="401980" cy="387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87088</cdr:x>
      <cdr:y>0.63427</cdr:y>
    </cdr:from>
    <cdr:to>
      <cdr:x>0.90522</cdr:x>
      <cdr:y>0.69542</cdr:y>
    </cdr:to>
    <cdr:sp macro="" textlink="">
      <cdr:nvSpPr>
        <cdr:cNvPr id="86" name="CasellaDiTesto 85"/>
        <cdr:cNvSpPr txBox="1"/>
      </cdr:nvSpPr>
      <cdr:spPr>
        <a:xfrm xmlns:a="http://schemas.openxmlformats.org/drawingml/2006/main" rot="16200000">
          <a:off x="8278594" y="6325109"/>
          <a:ext cx="597016" cy="3316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</a:t>
          </a:r>
        </a:p>
      </cdr:txBody>
    </cdr:sp>
  </cdr:relSizeAnchor>
  <cdr:relSizeAnchor xmlns:cdr="http://schemas.openxmlformats.org/drawingml/2006/chartDrawing">
    <cdr:from>
      <cdr:x>0.87743</cdr:x>
      <cdr:y>0.57191</cdr:y>
    </cdr:from>
    <cdr:to>
      <cdr:x>0.91281</cdr:x>
      <cdr:y>0.63533</cdr:y>
    </cdr:to>
    <cdr:sp macro="" textlink="">
      <cdr:nvSpPr>
        <cdr:cNvPr id="87" name="CasellaDiTesto 86"/>
        <cdr:cNvSpPr txBox="1"/>
      </cdr:nvSpPr>
      <cdr:spPr>
        <a:xfrm xmlns:a="http://schemas.openxmlformats.org/drawingml/2006/main" rot="16200000">
          <a:off x="8335748" y="5722364"/>
          <a:ext cx="619177" cy="3417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d</a:t>
          </a:r>
        </a:p>
      </cdr:txBody>
    </cdr:sp>
  </cdr:relSizeAnchor>
  <cdr:relSizeAnchor xmlns:cdr="http://schemas.openxmlformats.org/drawingml/2006/chartDrawing">
    <cdr:from>
      <cdr:x>0.88997</cdr:x>
      <cdr:y>0.58424</cdr:y>
    </cdr:from>
    <cdr:to>
      <cdr:x>0.90558</cdr:x>
      <cdr:y>0.63634</cdr:y>
    </cdr:to>
    <cdr:sp macro="" textlink="">
      <cdr:nvSpPr>
        <cdr:cNvPr id="88" name="CasellaDiTesto 87"/>
        <cdr:cNvSpPr txBox="1"/>
      </cdr:nvSpPr>
      <cdr:spPr>
        <a:xfrm xmlns:a="http://schemas.openxmlformats.org/drawingml/2006/main">
          <a:off x="8595632" y="5704058"/>
          <a:ext cx="150767" cy="5086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9216</cdr:x>
      <cdr:y>0.27363</cdr:y>
    </cdr:from>
    <cdr:to>
      <cdr:x>0.96292</cdr:x>
      <cdr:y>0.33026</cdr:y>
    </cdr:to>
    <cdr:sp macro="" textlink="">
      <cdr:nvSpPr>
        <cdr:cNvPr id="89" name="CasellaDiTesto 88"/>
        <cdr:cNvSpPr txBox="1"/>
      </cdr:nvSpPr>
      <cdr:spPr>
        <a:xfrm xmlns:a="http://schemas.openxmlformats.org/drawingml/2006/main">
          <a:off x="8616761" y="2671447"/>
          <a:ext cx="683425" cy="5528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</a:t>
          </a:r>
        </a:p>
      </cdr:txBody>
    </cdr:sp>
  </cdr:relSizeAnchor>
  <cdr:relSizeAnchor xmlns:cdr="http://schemas.openxmlformats.org/drawingml/2006/chartDrawing">
    <cdr:from>
      <cdr:x>0.10355</cdr:x>
      <cdr:y>0.786</cdr:y>
    </cdr:from>
    <cdr:to>
      <cdr:x>0.12722</cdr:x>
      <cdr:y>0.812</cdr:y>
    </cdr:to>
    <cdr:sp macro="" textlink="">
      <cdr:nvSpPr>
        <cdr:cNvPr id="90" name="TextBox 89">
          <a:extLst xmlns:a="http://schemas.openxmlformats.org/drawingml/2006/main">
            <a:ext uri="{FF2B5EF4-FFF2-40B4-BE49-F238E27FC236}">
              <a16:creationId xmlns:a16="http://schemas.microsoft.com/office/drawing/2014/main" xmlns="" id="{77CC6359-D5B4-48DE-8B2C-19E8BBD3A8AF}"/>
            </a:ext>
          </a:extLst>
        </cdr:cNvPr>
        <cdr:cNvSpPr txBox="1"/>
      </cdr:nvSpPr>
      <cdr:spPr>
        <a:xfrm xmlns:a="http://schemas.openxmlformats.org/drawingml/2006/main">
          <a:off x="1000125" y="7486653"/>
          <a:ext cx="228600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2978</cdr:x>
      <cdr:y>0.727</cdr:y>
    </cdr:from>
    <cdr:to>
      <cdr:x>0.26036</cdr:x>
      <cdr:y>0.751</cdr:y>
    </cdr:to>
    <cdr:sp macro="" textlink="">
      <cdr:nvSpPr>
        <cdr:cNvPr id="91" name="TextBox 90">
          <a:extLst xmlns:a="http://schemas.openxmlformats.org/drawingml/2006/main">
            <a:ext uri="{FF2B5EF4-FFF2-40B4-BE49-F238E27FC236}">
              <a16:creationId xmlns:a16="http://schemas.microsoft.com/office/drawing/2014/main" xmlns="" id="{19E44017-5C9A-4534-AD60-E3BA54A7FDE5}"/>
            </a:ext>
          </a:extLst>
        </cdr:cNvPr>
        <cdr:cNvSpPr txBox="1"/>
      </cdr:nvSpPr>
      <cdr:spPr>
        <a:xfrm xmlns:a="http://schemas.openxmlformats.org/drawingml/2006/main">
          <a:off x="2219325" y="6924677"/>
          <a:ext cx="295275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25148</cdr:x>
      <cdr:y>0.143</cdr:y>
    </cdr:from>
    <cdr:to>
      <cdr:x>0.28107</cdr:x>
      <cdr:y>0.172</cdr:y>
    </cdr:to>
    <cdr:sp macro="" textlink="">
      <cdr:nvSpPr>
        <cdr:cNvPr id="92" name="TextBox 91">
          <a:extLst xmlns:a="http://schemas.openxmlformats.org/drawingml/2006/main">
            <a:ext uri="{FF2B5EF4-FFF2-40B4-BE49-F238E27FC236}">
              <a16:creationId xmlns:a16="http://schemas.microsoft.com/office/drawing/2014/main" xmlns="" id="{299259A5-DCE5-42A5-BABA-BF9F9BCC2F79}"/>
            </a:ext>
          </a:extLst>
        </cdr:cNvPr>
        <cdr:cNvSpPr txBox="1"/>
      </cdr:nvSpPr>
      <cdr:spPr>
        <a:xfrm xmlns:a="http://schemas.openxmlformats.org/drawingml/2006/main">
          <a:off x="2428875" y="1362076"/>
          <a:ext cx="28575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5937</cdr:x>
      <cdr:y>0.132</cdr:y>
    </cdr:from>
    <cdr:to>
      <cdr:x>0.28304</cdr:x>
      <cdr:y>0.174</cdr:y>
    </cdr:to>
    <cdr:sp macro="" textlink="">
      <cdr:nvSpPr>
        <cdr:cNvPr id="93" name="TextBox 92">
          <a:extLst xmlns:a="http://schemas.openxmlformats.org/drawingml/2006/main">
            <a:ext uri="{FF2B5EF4-FFF2-40B4-BE49-F238E27FC236}">
              <a16:creationId xmlns:a16="http://schemas.microsoft.com/office/drawing/2014/main" xmlns="" id="{D775E9B6-8BA7-4337-A8F6-D6DFA847F95A}"/>
            </a:ext>
          </a:extLst>
        </cdr:cNvPr>
        <cdr:cNvSpPr txBox="1"/>
      </cdr:nvSpPr>
      <cdr:spPr>
        <a:xfrm xmlns:a="http://schemas.openxmlformats.org/drawingml/2006/main">
          <a:off x="2505075" y="1257302"/>
          <a:ext cx="228600" cy="4000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3136</cdr:x>
      <cdr:y>0.64195</cdr:y>
    </cdr:from>
    <cdr:to>
      <cdr:x>0.84714</cdr:x>
      <cdr:y>0.67024</cdr:y>
    </cdr:to>
    <cdr:sp macro="" textlink="">
      <cdr:nvSpPr>
        <cdr:cNvPr id="96" name="TextBox 95">
          <a:extLst xmlns:a="http://schemas.openxmlformats.org/drawingml/2006/main">
            <a:ext uri="{FF2B5EF4-FFF2-40B4-BE49-F238E27FC236}">
              <a16:creationId xmlns:a16="http://schemas.microsoft.com/office/drawing/2014/main" xmlns="" id="{657F79D7-C96C-4DC6-B792-9F0536BA4505}"/>
            </a:ext>
          </a:extLst>
        </cdr:cNvPr>
        <cdr:cNvSpPr txBox="1"/>
      </cdr:nvSpPr>
      <cdr:spPr>
        <a:xfrm xmlns:a="http://schemas.openxmlformats.org/drawingml/2006/main">
          <a:off x="8029575" y="6267453"/>
          <a:ext cx="15240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501</cdr:x>
      <cdr:y>0.13073</cdr:y>
    </cdr:from>
    <cdr:to>
      <cdr:x>0.87673</cdr:x>
      <cdr:y>0.15805</cdr:y>
    </cdr:to>
    <cdr:sp macro="" textlink="">
      <cdr:nvSpPr>
        <cdr:cNvPr id="97" name="TextBox 96">
          <a:extLst xmlns:a="http://schemas.openxmlformats.org/drawingml/2006/main">
            <a:ext uri="{FF2B5EF4-FFF2-40B4-BE49-F238E27FC236}">
              <a16:creationId xmlns:a16="http://schemas.microsoft.com/office/drawing/2014/main" xmlns="" id="{A267D08E-940E-4224-A1F1-1B969F0A780E}"/>
            </a:ext>
          </a:extLst>
        </cdr:cNvPr>
        <cdr:cNvSpPr txBox="1"/>
      </cdr:nvSpPr>
      <cdr:spPr>
        <a:xfrm xmlns:a="http://schemas.openxmlformats.org/drawingml/2006/main">
          <a:off x="8210550" y="1276353"/>
          <a:ext cx="257175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90927</cdr:x>
      <cdr:y>0.12976</cdr:y>
    </cdr:from>
    <cdr:to>
      <cdr:x>0.94477</cdr:x>
      <cdr:y>0.16781</cdr:y>
    </cdr:to>
    <cdr:sp macro="" textlink="">
      <cdr:nvSpPr>
        <cdr:cNvPr id="98" name="TextBox 97">
          <a:extLst xmlns:a="http://schemas.openxmlformats.org/drawingml/2006/main">
            <a:ext uri="{FF2B5EF4-FFF2-40B4-BE49-F238E27FC236}">
              <a16:creationId xmlns:a16="http://schemas.microsoft.com/office/drawing/2014/main" xmlns="" id="{8D870929-DAA9-4EE6-995C-F05DEF618158}"/>
            </a:ext>
          </a:extLst>
        </cdr:cNvPr>
        <cdr:cNvSpPr txBox="1"/>
      </cdr:nvSpPr>
      <cdr:spPr>
        <a:xfrm xmlns:a="http://schemas.openxmlformats.org/drawingml/2006/main">
          <a:off x="8782050" y="1266828"/>
          <a:ext cx="342900" cy="3714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8317</cdr:x>
      <cdr:y>0</cdr:y>
    </cdr:from>
    <cdr:to>
      <cdr:x>1</cdr:x>
      <cdr:y>0.05385</cdr:y>
    </cdr:to>
    <cdr:sp macro="" textlink="">
      <cdr:nvSpPr>
        <cdr:cNvPr id="99" name="Rettangolo 98"/>
        <cdr:cNvSpPr/>
      </cdr:nvSpPr>
      <cdr:spPr>
        <a:xfrm xmlns:a="http://schemas.openxmlformats.org/drawingml/2006/main">
          <a:off x="5976707" y="0"/>
          <a:ext cx="2771757" cy="3693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>
          <a:spAutoFit/>
        </a:bodyPr>
        <a:lstStyle xmlns:a="http://schemas.openxmlformats.org/drawingml/2006/main">
          <a:defPPr>
            <a:defRPr lang="it-IT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b="1" dirty="0" err="1" smtClean="0"/>
            <a:t>Magnolol</a:t>
          </a:r>
          <a:r>
            <a:rPr lang="en-GB" b="1" dirty="0" smtClean="0"/>
            <a:t> </a:t>
          </a:r>
          <a:r>
            <a:rPr lang="en-GB" b="1" dirty="0" err="1" smtClean="0"/>
            <a:t>monoacetate</a:t>
          </a:r>
          <a:r>
            <a:rPr lang="en-GB" b="1" dirty="0" smtClean="0"/>
            <a:t> </a:t>
          </a:r>
          <a:r>
            <a:rPr lang="en-GB" b="1" dirty="0"/>
            <a:t>3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lc="http://schemas.openxmlformats.org/drawingml/2006/lockedCanvas" xmlns:a16="http://schemas.microsoft.com/office/drawing/2014/main" xmlns="" xmlns:xdr="http://schemas.openxmlformats.org/drawingml/2006/spreadsheetDrawing" id="{00000000-0008-0000-03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0610378"/>
              </p:ext>
            </p:extLst>
          </p:nvPr>
        </p:nvGraphicFramePr>
        <p:xfrm>
          <a:off x="0" y="0"/>
          <a:ext cx="8748464" cy="6858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12138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4</TotalTime>
  <Words>112</Words>
  <Application>Microsoft Office PowerPoint</Application>
  <PresentationFormat>Presentazione su schermo (4:3)</PresentationFormat>
  <Paragraphs>9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7:09Z</dcterms:modified>
</cp:coreProperties>
</file>